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264275" cy="84232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2514" y="96"/>
      </p:cViewPr>
      <p:guideLst>
        <p:guide orient="horz" pos="2653"/>
        <p:guide pos="1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00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075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157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631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69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745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4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36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80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3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188B-89DE-4669-91B1-F88FE6179B89}" type="datetimeFigureOut">
              <a:rPr kumimoji="1" lang="ja-JP" altLang="en-US" smtClean="0"/>
              <a:t>2019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64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301" y="1428139"/>
            <a:ext cx="2808000" cy="28080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235974" y="140110"/>
            <a:ext cx="4249881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</a:t>
            </a:r>
            <a:r>
              <a:rPr kumimoji="1"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gure</a:t>
            </a:r>
            <a:r>
              <a:rPr kumimoji="1"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3</a:t>
            </a:r>
            <a:endParaRPr kumimoji="1" lang="en-US" altLang="ja-JP" sz="11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nhattan plot and QQ plot of genome-wide association analysis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5974" y="882817"/>
            <a:ext cx="1266693" cy="317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</a:t>
            </a:r>
            <a:r>
              <a:rPr kumimoji="1"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sets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801301" y="3133386"/>
            <a:ext cx="978153" cy="346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λGC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= 1.007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70" y="1199827"/>
            <a:ext cx="3240000" cy="32400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70" y="4756837"/>
            <a:ext cx="3240000" cy="324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275" y="4972837"/>
            <a:ext cx="2808000" cy="2808000"/>
          </a:xfrm>
          <a:prstGeom prst="rect">
            <a:avLst/>
          </a:prstGeom>
        </p:spPr>
      </p:pic>
      <p:sp>
        <p:nvSpPr>
          <p:cNvPr id="17" name="テキスト ボックス 16"/>
          <p:cNvSpPr txBox="1"/>
          <p:nvPr/>
        </p:nvSpPr>
        <p:spPr>
          <a:xfrm>
            <a:off x="4860275" y="6810864"/>
            <a:ext cx="978153" cy="346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λGC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= 1.001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9226" y="4637243"/>
            <a:ext cx="1699504" cy="346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 + Test</a:t>
            </a:r>
            <a:r>
              <a:rPr kumimoji="1"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sets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135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24</Words>
  <Application>Microsoft Office PowerPoint</Application>
  <PresentationFormat>ユーザー設定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6</cp:revision>
  <dcterms:created xsi:type="dcterms:W3CDTF">2019-06-03T06:47:50Z</dcterms:created>
  <dcterms:modified xsi:type="dcterms:W3CDTF">2019-06-14T01:27:10Z</dcterms:modified>
</cp:coreProperties>
</file>